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8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107" d="100"/>
          <a:sy n="107" d="100"/>
        </p:scale>
        <p:origin x="64" y="5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656CFE7-3728-46A6-A816-B6FC9F7BA5E6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1563CF0-9105-4B39-8D00-87D5767490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89155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2451FA7-5DFE-5431-AA28-EE564648A5E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A471E9B6-9C44-F977-C1C6-E79ED568461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75784D9-31D0-8F05-0194-C143DC2E9B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5CF83-2C42-4C78-B25B-1C6A61D79F7A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B45989F-9F6A-AF9C-30B8-6FC2934FB2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89503A1-AAE6-F20B-2A47-ECD752095A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D5124-8412-47D8-8D0F-D1F36F593A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71913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8749E2C-A2ED-9D17-9FC6-F6021E544C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6BD7978-FABF-EFF5-CFF5-98FA2FCA64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33D32E2-34DA-553A-84C4-813CF929D6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5CF83-2C42-4C78-B25B-1C6A61D79F7A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0A2964A-B407-7628-9346-B171A0C2A3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8346CC8-10CB-77CF-277D-C2CCD4748D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D5124-8412-47D8-8D0F-D1F36F593A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06207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1535B8D7-BCC0-E347-CA1F-0A5C325CE21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F6595B6-782D-B112-F456-0E0EF0D7A80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F0DF0FE-E6CE-0212-9C9A-3CD96C5FE0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5CF83-2C42-4C78-B25B-1C6A61D79F7A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9814757-4BDA-F32C-9624-E64CC3EB3B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24862BE-2704-F834-5B1E-A5ECB99BE5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D5124-8412-47D8-8D0F-D1F36F593A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9364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F10E780-88AE-BA13-6736-CF46173FFF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7F052DB-FEE9-CF0C-F873-78F01418478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277B93A-2F05-6A3D-2FB9-A1C26E5280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5CF83-2C42-4C78-B25B-1C6A61D79F7A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A1FE76D-3506-FA59-5567-2E75645C46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12B2944-559B-335F-AD26-EEC993CAB0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D5124-8412-47D8-8D0F-D1F36F593A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44883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008018B-14BA-A320-59F5-4164FF58A2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D3E3DF8-92F8-2AE6-A58E-28BA232F7F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D66B62D-84AE-1586-4264-FC31FA95F4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5CF83-2C42-4C78-B25B-1C6A61D79F7A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1D2CF3C-D0FC-E995-B005-A15CF35ABA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A657DD1-2BEE-B9D0-F5D6-4F12A24740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D5124-8412-47D8-8D0F-D1F36F593A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97881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73585E6-B9E5-E6FC-2C6B-B1636CBF68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B688FC6-7108-FF7F-CB9E-5E4C0CA57C6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3B4D43F-1E29-B8C4-019A-12B974EF71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2680BEF-88C1-6ABD-012B-B0CF1BAEE6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5CF83-2C42-4C78-B25B-1C6A61D79F7A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BA7F857-5811-DE74-5B95-2DDCD1D009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7D81CD7-88C5-33D7-5B57-E4E5FF62D2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D5124-8412-47D8-8D0F-D1F36F593A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05067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34A59F0-7E53-6E9B-E142-9CDA11B8CC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70BD9C5-28BF-D6EB-0DBD-0803EF230C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28CEA37-5A7F-DED3-9A33-FFF077E55FC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E8ED4524-798B-40D1-A12E-DB12A9D90D2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6C904F39-A0EF-6556-3498-45508686FAF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FEEA19F1-282C-D972-5B8C-00A868B4EC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5CF83-2C42-4C78-B25B-1C6A61D79F7A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90FC5505-823A-E4A6-9C67-3A6DBF3D40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91D4DF69-08E2-8BFD-5C1F-AF926D7EB5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D5124-8412-47D8-8D0F-D1F36F593A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59905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97E177D-8B53-E6F8-7796-75ED07BE80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B867B60-65F6-F405-8970-2F1DDC417F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5CF83-2C42-4C78-B25B-1C6A61D79F7A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7A0358FB-63F7-4143-BAC0-0D10E17855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CF4A270E-64DC-9B85-CDF5-993FB47C30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D5124-8412-47D8-8D0F-D1F36F593A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91981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0A3EFDE0-A157-CEFB-6953-B6801BE07C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5CF83-2C42-4C78-B25B-1C6A61D79F7A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3BB55299-BA9E-BF1F-7C9D-59DF566021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82EB8C6-503F-1600-3583-813F7E1AF2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D5124-8412-47D8-8D0F-D1F36F593A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59788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BAD4990-EB27-9D43-4643-4982059347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9FC3363-A2A8-C378-C186-266623C4D8E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71800E3-8ECA-4608-D250-D0063BF005C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7891A50-5A42-C86E-7B77-674DC60455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5CF83-2C42-4C78-B25B-1C6A61D79F7A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8ED8C94-3E91-18AE-A392-EB1863DC2F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8DB93FA-BE2D-6160-10B9-39EF6F34D5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D5124-8412-47D8-8D0F-D1F36F593A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46693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219E441-C4AD-48C9-14EE-1A20EA63AB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96E4B0C2-636F-061B-EE1E-A6A467B1E52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5C679B4-8707-E305-E847-7ADB0D156C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E0A383E-4A21-B7DD-D30C-060CB1BFAD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5CF83-2C42-4C78-B25B-1C6A61D79F7A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DC6C21C-CBA3-6467-D9AD-7C3CB09746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672BDFC-7C72-C2C0-C6E9-485F031C4F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D5124-8412-47D8-8D0F-D1F36F593A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6358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562EB5CF-C928-800F-07ED-42814BCB2F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9638439-66AA-6CE7-3C0A-A81AE34368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89793B6-3E7B-486B-5EE5-11D29AE2AC4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85CF83-2C42-4C78-B25B-1C6A61D79F7A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95448B7-6CBD-23C3-C38B-A519F312336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F3E7A14-5C60-AC27-6032-5AE2BEA0326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3D5124-8412-47D8-8D0F-D1F36F593A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19308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C1E3B91B-34B0-4B6F-B77D-AB90893D97D4}"/>
              </a:ext>
            </a:extLst>
          </p:cNvPr>
          <p:cNvSpPr/>
          <p:nvPr/>
        </p:nvSpPr>
        <p:spPr>
          <a:xfrm>
            <a:off x="110532" y="1165609"/>
            <a:ext cx="12081468" cy="569239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1737FC5D-0395-4037-A714-523313BDD812}"/>
              </a:ext>
            </a:extLst>
          </p:cNvPr>
          <p:cNvSpPr/>
          <p:nvPr/>
        </p:nvSpPr>
        <p:spPr>
          <a:xfrm>
            <a:off x="3645984" y="1562804"/>
            <a:ext cx="2109270" cy="98970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T-bet or CXCR3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positive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B22A569B-F1DF-48C8-B211-816991EEF773}"/>
              </a:ext>
            </a:extLst>
          </p:cNvPr>
          <p:cNvSpPr/>
          <p:nvPr/>
        </p:nvSpPr>
        <p:spPr>
          <a:xfrm>
            <a:off x="6592749" y="1562804"/>
            <a:ext cx="2075775" cy="98970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GATA3 or CCR4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positive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8" name="直線矢印コネクタ 7">
            <a:extLst>
              <a:ext uri="{FF2B5EF4-FFF2-40B4-BE49-F238E27FC236}">
                <a16:creationId xmlns:a16="http://schemas.microsoft.com/office/drawing/2014/main" id="{0481022E-6DC7-4DF2-9F18-FC1F196A1610}"/>
              </a:ext>
            </a:extLst>
          </p:cNvPr>
          <p:cNvCxnSpPr/>
          <p:nvPr/>
        </p:nvCxnSpPr>
        <p:spPr>
          <a:xfrm>
            <a:off x="4713333" y="2743507"/>
            <a:ext cx="0" cy="54000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矢印コネクタ 10">
            <a:extLst>
              <a:ext uri="{FF2B5EF4-FFF2-40B4-BE49-F238E27FC236}">
                <a16:creationId xmlns:a16="http://schemas.microsoft.com/office/drawing/2014/main" id="{201E43CC-B9A0-4894-A197-1B6B411658D3}"/>
              </a:ext>
            </a:extLst>
          </p:cNvPr>
          <p:cNvCxnSpPr/>
          <p:nvPr/>
        </p:nvCxnSpPr>
        <p:spPr>
          <a:xfrm>
            <a:off x="7686890" y="2743507"/>
            <a:ext cx="0" cy="54000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5353025D-90E8-4E5F-B948-F4FE88ADFF42}"/>
              </a:ext>
            </a:extLst>
          </p:cNvPr>
          <p:cNvSpPr/>
          <p:nvPr/>
        </p:nvSpPr>
        <p:spPr>
          <a:xfrm>
            <a:off x="672651" y="1562803"/>
            <a:ext cx="2109269" cy="98970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PTCL-NOS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(n=100)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17" name="直線矢印コネクタ 16">
            <a:extLst>
              <a:ext uri="{FF2B5EF4-FFF2-40B4-BE49-F238E27FC236}">
                <a16:creationId xmlns:a16="http://schemas.microsoft.com/office/drawing/2014/main" id="{C89DAF31-5626-472D-B003-BF836E2153A9}"/>
              </a:ext>
            </a:extLst>
          </p:cNvPr>
          <p:cNvCxnSpPr>
            <a:cxnSpLocks/>
          </p:cNvCxnSpPr>
          <p:nvPr/>
        </p:nvCxnSpPr>
        <p:spPr>
          <a:xfrm>
            <a:off x="2903972" y="2057657"/>
            <a:ext cx="602901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187E9C21-F379-46D9-9EE9-1BDE24DD29C5}"/>
              </a:ext>
            </a:extLst>
          </p:cNvPr>
          <p:cNvSpPr txBox="1"/>
          <p:nvPr/>
        </p:nvSpPr>
        <p:spPr>
          <a:xfrm>
            <a:off x="5758132" y="1578055"/>
            <a:ext cx="7034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NO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rgbClr val="0070C0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274A3F94-E443-409A-9536-D9EE924A79A2}"/>
              </a:ext>
            </a:extLst>
          </p:cNvPr>
          <p:cNvSpPr/>
          <p:nvPr/>
        </p:nvSpPr>
        <p:spPr>
          <a:xfrm>
            <a:off x="3645984" y="3429000"/>
            <a:ext cx="2109271" cy="99293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PTCL-TBX21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(n=55)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4D0F2478-1198-4D57-804B-B8E90A6B9676}"/>
              </a:ext>
            </a:extLst>
          </p:cNvPr>
          <p:cNvSpPr/>
          <p:nvPr/>
        </p:nvSpPr>
        <p:spPr>
          <a:xfrm>
            <a:off x="6592749" y="3432222"/>
            <a:ext cx="2075775" cy="98970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PTCL-GATA3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(n=24)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5" name="正方形/長方形 24">
            <a:extLst>
              <a:ext uri="{FF2B5EF4-FFF2-40B4-BE49-F238E27FC236}">
                <a16:creationId xmlns:a16="http://schemas.microsoft.com/office/drawing/2014/main" id="{19C9FCED-0297-4322-96A4-5CD0A4B2F294}"/>
              </a:ext>
            </a:extLst>
          </p:cNvPr>
          <p:cNvSpPr/>
          <p:nvPr/>
        </p:nvSpPr>
        <p:spPr>
          <a:xfrm>
            <a:off x="9506019" y="1562804"/>
            <a:ext cx="2075774" cy="98970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PTCL-unclassified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(n</a:t>
            </a:r>
            <a:r>
              <a:rPr kumimoji="1" lang="en-US" altLang="ja-JP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=21)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B159F181-5513-41FF-8950-FCE03A8D7D37}"/>
              </a:ext>
            </a:extLst>
          </p:cNvPr>
          <p:cNvSpPr txBox="1"/>
          <p:nvPr/>
        </p:nvSpPr>
        <p:spPr>
          <a:xfrm>
            <a:off x="457177" y="4652758"/>
            <a:ext cx="11651087" cy="20595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l figure 1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. Immunohistochemical algorithm of classification for PTCL-NOS</a:t>
            </a:r>
            <a:r>
              <a:rPr kumimoji="1" lang="en-US" altLang="ja-JP" sz="18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16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.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I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f tumor cells were positive for T-bet or CXCR3 more than 20%, those cases were classified as PTCL-TBX21.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In the cases not classified as PTCL-TBX21, if tumor cells were positive for GATA3 or CCR4 more than 50%, those cases were classified as PTCL-GATA3.The cases not classified as PTCL-TBX21 or PTCL-GATA3 were determined as PTCL-unclassified.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ccording to this algorithm, 55 cases in PTCL-TBX21 (55%), 24 cases in PTCL-GATA3 (24%), and 21 cases in PTCL-unclassified (21%) were observed in 100 PTCL-NOS cases.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02556338-D2B5-4AFA-9C34-3AE5BA1022E5}"/>
              </a:ext>
            </a:extLst>
          </p:cNvPr>
          <p:cNvSpPr txBox="1"/>
          <p:nvPr/>
        </p:nvSpPr>
        <p:spPr>
          <a:xfrm>
            <a:off x="4937026" y="2828841"/>
            <a:ext cx="7034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YES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22" name="直線矢印コネクタ 21">
            <a:extLst>
              <a:ext uri="{FF2B5EF4-FFF2-40B4-BE49-F238E27FC236}">
                <a16:creationId xmlns:a16="http://schemas.microsoft.com/office/drawing/2014/main" id="{96A766CE-941A-4250-8B6E-DE6D9287BF19}"/>
              </a:ext>
            </a:extLst>
          </p:cNvPr>
          <p:cNvCxnSpPr>
            <a:cxnSpLocks/>
          </p:cNvCxnSpPr>
          <p:nvPr/>
        </p:nvCxnSpPr>
        <p:spPr>
          <a:xfrm>
            <a:off x="5858681" y="2057657"/>
            <a:ext cx="602901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矢印コネクタ 27">
            <a:extLst>
              <a:ext uri="{FF2B5EF4-FFF2-40B4-BE49-F238E27FC236}">
                <a16:creationId xmlns:a16="http://schemas.microsoft.com/office/drawing/2014/main" id="{C8C1A900-10B6-4E20-98BD-2E26D37FDDBB}"/>
              </a:ext>
            </a:extLst>
          </p:cNvPr>
          <p:cNvCxnSpPr>
            <a:cxnSpLocks/>
          </p:cNvCxnSpPr>
          <p:nvPr/>
        </p:nvCxnSpPr>
        <p:spPr>
          <a:xfrm>
            <a:off x="8765146" y="2057657"/>
            <a:ext cx="602901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5981E58C-D2D8-49EE-A976-CA11A0DD851D}"/>
              </a:ext>
            </a:extLst>
          </p:cNvPr>
          <p:cNvSpPr txBox="1"/>
          <p:nvPr/>
        </p:nvSpPr>
        <p:spPr>
          <a:xfrm>
            <a:off x="8714872" y="1578055"/>
            <a:ext cx="7034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NO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rgbClr val="0070C0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B4D7DB36-B6BE-4A00-9AE2-6F3835B95687}"/>
              </a:ext>
            </a:extLst>
          </p:cNvPr>
          <p:cNvSpPr txBox="1"/>
          <p:nvPr/>
        </p:nvSpPr>
        <p:spPr>
          <a:xfrm>
            <a:off x="7842985" y="2828841"/>
            <a:ext cx="8255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YES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101496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42</Words>
  <Application>Microsoft Office PowerPoint</Application>
  <PresentationFormat>ワイド画面</PresentationFormat>
  <Paragraphs>2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島崎 裕正</dc:creator>
  <cp:lastModifiedBy>三好　寛明</cp:lastModifiedBy>
  <cp:revision>7</cp:revision>
  <dcterms:created xsi:type="dcterms:W3CDTF">2023-07-01T07:56:45Z</dcterms:created>
  <dcterms:modified xsi:type="dcterms:W3CDTF">2023-08-14T07:14:49Z</dcterms:modified>
</cp:coreProperties>
</file>